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356" r:id="rId2"/>
    <p:sldId id="358" r:id="rId3"/>
    <p:sldId id="355" r:id="rId4"/>
    <p:sldId id="357" r:id="rId5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orient="horz" pos="1918" userDrawn="1">
          <p15:clr>
            <a:srgbClr val="A4A3A4"/>
          </p15:clr>
        </p15:guide>
        <p15:guide id="4" pos="3657" userDrawn="1">
          <p15:clr>
            <a:srgbClr val="A4A3A4"/>
          </p15:clr>
        </p15:guide>
        <p15:guide id="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CC33"/>
    <a:srgbClr val="0000FF"/>
    <a:srgbClr val="009999"/>
    <a:srgbClr val="FFFFCC"/>
    <a:srgbClr val="FFFF00"/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2376" y="48"/>
      </p:cViewPr>
      <p:guideLst>
        <p:guide orient="horz" pos="1918"/>
        <p:guide pos="3657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79" d="100"/>
        <a:sy n="179" d="100"/>
      </p:scale>
      <p:origin x="0" y="-229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5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B5BDD4-8185-49E3-BE3A-876FE6FCBEA9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5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34237F-0AA2-4ED4-87A6-D07D250C563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2399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030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743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978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973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611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360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7294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757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663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859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320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EC6ADD-E8CD-440E-BDA4-E8A80BC015F7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8C913A-013D-48C8-B72E-8E9B1F71880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8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297180" y="1482761"/>
            <a:ext cx="64185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Table 1: At least 100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duc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genes in wild typ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otat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3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ounding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.p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: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rovided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3d / 0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648" y="2355569"/>
            <a:ext cx="6300000" cy="436598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4050" y="6922799"/>
            <a:ext cx="1778725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95361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297181" y="2316480"/>
            <a:ext cx="630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Table 2: At least 100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duc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genes in wild typ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otat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7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ounding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.p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: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rovided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7d / 0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181" y="3183928"/>
            <a:ext cx="6300000" cy="3194278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8712" y="6682740"/>
            <a:ext cx="1800000" cy="10929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59428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404757" y="1437939"/>
            <a:ext cx="62255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Table 3: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Highes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xpress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genes in wild typ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otat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3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ounding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.p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: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rovid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350" y="2173759"/>
            <a:ext cx="6300000" cy="4435039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1172" y="6977231"/>
            <a:ext cx="1983275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27108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297181" y="2316480"/>
            <a:ext cx="60833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Table 4: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Highes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xpress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genes in wild typ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otat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7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ounding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.p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: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rovided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3380" y="3189288"/>
            <a:ext cx="6300000" cy="3299234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5137" y="6899665"/>
            <a:ext cx="1983275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6671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2</Words>
  <Application>Microsoft Office PowerPoint</Application>
  <PresentationFormat>A4-Papier (210 x 297 mm)</PresentationFormat>
  <Paragraphs>10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Company>IPB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sahl, Sabine</dc:creator>
  <cp:lastModifiedBy>Rosahl, Sabine</cp:lastModifiedBy>
  <cp:revision>672</cp:revision>
  <cp:lastPrinted>2024-02-12T09:32:38Z</cp:lastPrinted>
  <dcterms:created xsi:type="dcterms:W3CDTF">2021-02-04T13:39:50Z</dcterms:created>
  <dcterms:modified xsi:type="dcterms:W3CDTF">2024-10-25T12:45:42Z</dcterms:modified>
</cp:coreProperties>
</file>